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49"/>
    <p:restoredTop sz="94714"/>
  </p:normalViewPr>
  <p:slideViewPr>
    <p:cSldViewPr snapToGrid="0" snapToObjects="1">
      <p:cViewPr varScale="1">
        <p:scale>
          <a:sx n="112" d="100"/>
          <a:sy n="112" d="100"/>
        </p:scale>
        <p:origin x="46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DA732AE-BC11-3542-8897-B7162E05B54C}" type="datetimeFigureOut">
              <a:rPr lang="en-US" smtClean="0"/>
              <a:t>1/1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13C049E-FAE4-E942-BF9E-F521A854F3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9809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13C049E-FAE4-E942-BF9E-F521A854F3D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136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22E9DB-EE0A-DBFD-F5CA-09B68F3E5E5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DA8E039-7378-A85D-3B98-2DD41B4CE89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97CE43-CB75-F13A-9FB5-1058C440D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6F2C7-9A7B-EE4B-9F28-B12C9B5D14FF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75153A-9C54-5D29-CB83-008FFBBE39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933E1A-7D69-83BA-BDDA-EDD67618E5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58ED3-C09F-754C-85E4-F5C60924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2223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447EC7-2584-2FA0-148C-230DF41F33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41833B-DDBC-DA2E-14DA-82942D4BD53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8D3237-0189-9D05-81E0-9085AAAA5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6F2C7-9A7B-EE4B-9F28-B12C9B5D14FF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78CFE4-AEE2-B6E8-45ED-83BFB03981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18C859-5F13-AD98-4235-795DD8C855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58ED3-C09F-754C-85E4-F5C60924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086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616CDE6-886B-6BB0-CAE8-8E90C6AB55F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1818563-EB04-4F8F-8046-2F50CCD0E9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21E460-620B-0887-6D7D-692AEF7A77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6F2C7-9A7B-EE4B-9F28-B12C9B5D14FF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CA6593-F26A-8FC0-BF06-8C0BFA6573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BAADE7-FC3F-B681-3099-0EC3D5EEFB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58ED3-C09F-754C-85E4-F5C60924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80722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D514E4-6DB1-92CD-A896-FCA4DA9F4F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ADFF8D-6349-DF70-AAFE-13F471EB284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FC6276-4992-740E-7BE4-D06E446B3B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6F2C7-9A7B-EE4B-9F28-B12C9B5D14FF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02055D-8902-ADBF-2451-921794604F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3730BCE-4536-3370-E936-44008AC5E9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58ED3-C09F-754C-85E4-F5C60924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39316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5CEFE2-E8B4-2A21-7505-F07DB4AD9B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C59FFA-A69B-1D4A-6504-C1FE0E8887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838F45-3E11-4B19-EA5B-D75F06151A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6F2C7-9A7B-EE4B-9F28-B12C9B5D14FF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8FE714-1CC5-1A33-513A-3C4F0934A2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00C76C-8EC0-0A6B-0A7B-B1100797F9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58ED3-C09F-754C-85E4-F5C60924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8967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F169B7-5A6A-FF78-3E0A-33525D0D43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754AAA-E9BA-2E44-1443-132874DBB5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C8AB50-494B-AB17-FA8F-1C2BA05FEE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2DA03E-D8B7-D9F7-DD89-AE87D4575D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6F2C7-9A7B-EE4B-9F28-B12C9B5D14FF}" type="datetimeFigureOut">
              <a:rPr lang="en-US" smtClean="0"/>
              <a:t>1/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6E4512-895B-C6F5-ADDD-1BEC225829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BB23B2-4D72-7C37-47A6-C82049BB6E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58ED3-C09F-754C-85E4-F5C60924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36916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70B7E6-C21F-DC6B-AF1D-DDF0F6A8CF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C9C06A2-5645-9332-3CD5-29B8510901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64BAAA-2878-1A0C-DF04-92E260A2D9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EB5C4E3-3F6D-1F63-AA02-BEDAA4D475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853E57E-DF66-E753-38D7-7F8A2095E6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2954223-4D4E-DB9D-8110-EC189CCC8E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6F2C7-9A7B-EE4B-9F28-B12C9B5D14FF}" type="datetimeFigureOut">
              <a:rPr lang="en-US" smtClean="0"/>
              <a:t>1/1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979D380-0506-10C9-1A95-29BBD29E9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DF8210D-73EF-6467-7727-1B307A7684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58ED3-C09F-754C-85E4-F5C60924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6145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6E9966-0644-2644-5050-8389FF6678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30917C-5ED9-3251-DCBB-45780C22B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6F2C7-9A7B-EE4B-9F28-B12C9B5D14FF}" type="datetimeFigureOut">
              <a:rPr lang="en-US" smtClean="0"/>
              <a:t>1/1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ADB7291-84C7-5306-A1CC-C7EA314C97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31BE505-62DE-A624-0651-66F20E9A91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58ED3-C09F-754C-85E4-F5C60924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9125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306D99C-30BF-4BDB-67BB-D76760A47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6F2C7-9A7B-EE4B-9F28-B12C9B5D14FF}" type="datetimeFigureOut">
              <a:rPr lang="en-US" smtClean="0"/>
              <a:t>1/1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5AFCA9E-A3F6-0B35-F8CA-39AFD72DC1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91562E9-BF45-BD7A-65A0-843B597D1A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58ED3-C09F-754C-85E4-F5C60924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12438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A925E0-6165-E3EB-C62A-E4DF223933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8EB2CE-9015-82E8-F5C8-AFB3A344CEF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122681-7B09-A4A3-6691-25314BC302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ECC321-35AB-8EAB-14FB-1218434A7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6F2C7-9A7B-EE4B-9F28-B12C9B5D14FF}" type="datetimeFigureOut">
              <a:rPr lang="en-US" smtClean="0"/>
              <a:t>1/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8A3AE09-4474-05F8-5689-9CEFB9BD35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87E3E3-8ACC-E1BC-CA0D-5C4B692C1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58ED3-C09F-754C-85E4-F5C60924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50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5804F8-A935-C13B-CD1C-A5C89FDA11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F88F2F2-16DB-1367-47B2-85F61958E9D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4741D1-312C-3100-5BB5-48A1DE6D66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1F3059-C779-7A99-6B65-F237A82A4A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6F2C7-9A7B-EE4B-9F28-B12C9B5D14FF}" type="datetimeFigureOut">
              <a:rPr lang="en-US" smtClean="0"/>
              <a:t>1/1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36AB54F-6B3A-8823-E128-B509E69DA0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0B0BA70-8D33-1C61-D489-F504CD1665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058ED3-C09F-754C-85E4-F5C60924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6282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5AAA2F4-4D24-5589-E53C-934714C873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BF40E5-4DED-336E-A0E2-FACD81931E4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9AD8CF3-6A11-DE9B-1C9D-7A978789834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56F2C7-9A7B-EE4B-9F28-B12C9B5D14FF}" type="datetimeFigureOut">
              <a:rPr lang="en-US" smtClean="0"/>
              <a:t>1/1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ECA0FE-EE3F-9E30-A5F5-D89C5634A66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A1E45B-6B4B-C9C6-0734-79F1B8FBFA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058ED3-C09F-754C-85E4-F5C60924AD5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6739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box and whisker chart&#10;&#10;Description automatically generated">
            <a:extLst>
              <a:ext uri="{FF2B5EF4-FFF2-40B4-BE49-F238E27FC236}">
                <a16:creationId xmlns:a16="http://schemas.microsoft.com/office/drawing/2014/main" id="{D3DFFC68-CA7B-035E-1D36-A5EBCB7E808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09541" y="270743"/>
            <a:ext cx="4258669" cy="3128208"/>
          </a:xfrm>
          <a:prstGeom prst="rect">
            <a:avLst/>
          </a:prstGeom>
        </p:spPr>
      </p:pic>
      <p:pic>
        <p:nvPicPr>
          <p:cNvPr id="5" name="Picture 4" descr="Chart, box and whisker chart&#10;&#10;Description automatically generated">
            <a:extLst>
              <a:ext uri="{FF2B5EF4-FFF2-40B4-BE49-F238E27FC236}">
                <a16:creationId xmlns:a16="http://schemas.microsoft.com/office/drawing/2014/main" id="{0052F2DD-2BAC-EEC6-8912-D57651CC449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00115" y="252910"/>
            <a:ext cx="4258667" cy="3119444"/>
          </a:xfrm>
          <a:prstGeom prst="rect">
            <a:avLst/>
          </a:prstGeom>
        </p:spPr>
      </p:pic>
      <p:pic>
        <p:nvPicPr>
          <p:cNvPr id="7" name="Picture 6" descr="Chart, box and whisker chart&#10;&#10;Description automatically generated">
            <a:extLst>
              <a:ext uri="{FF2B5EF4-FFF2-40B4-BE49-F238E27FC236}">
                <a16:creationId xmlns:a16="http://schemas.microsoft.com/office/drawing/2014/main" id="{2B8537A8-CD1E-3F15-5427-329C74F31E9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82438" y="3398951"/>
            <a:ext cx="4050082" cy="2975340"/>
          </a:xfrm>
          <a:prstGeom prst="rect">
            <a:avLst/>
          </a:prstGeom>
        </p:spPr>
      </p:pic>
      <p:pic>
        <p:nvPicPr>
          <p:cNvPr id="9" name="Picture 8" descr="Chart, box and whisker chart&#10;&#10;Description automatically generated">
            <a:extLst>
              <a:ext uri="{FF2B5EF4-FFF2-40B4-BE49-F238E27FC236}">
                <a16:creationId xmlns:a16="http://schemas.microsoft.com/office/drawing/2014/main" id="{A38A1D5A-CB55-AD91-3C05-C11A05AEED6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81809" y="3368510"/>
            <a:ext cx="4196206" cy="3082688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83B48E27-BDF4-0331-18F8-69BD5A4C1026}"/>
              </a:ext>
            </a:extLst>
          </p:cNvPr>
          <p:cNvSpPr txBox="1"/>
          <p:nvPr/>
        </p:nvSpPr>
        <p:spPr>
          <a:xfrm>
            <a:off x="2233047" y="3378262"/>
            <a:ext cx="10058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PF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C069069-777C-1480-25C4-8185A4A57681}"/>
              </a:ext>
            </a:extLst>
          </p:cNvPr>
          <p:cNvSpPr txBox="1"/>
          <p:nvPr/>
        </p:nvSpPr>
        <p:spPr>
          <a:xfrm rot="16200000">
            <a:off x="411547" y="2989999"/>
            <a:ext cx="12342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Femal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DDA0FD0-07AC-25B3-C47E-69688786B673}"/>
              </a:ext>
            </a:extLst>
          </p:cNvPr>
          <p:cNvSpPr txBox="1"/>
          <p:nvPr/>
        </p:nvSpPr>
        <p:spPr>
          <a:xfrm rot="16200000">
            <a:off x="5289873" y="2896248"/>
            <a:ext cx="12726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Male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D118E8E-9A63-10E6-8F11-F3106E1F6428}"/>
              </a:ext>
            </a:extLst>
          </p:cNvPr>
          <p:cNvSpPr txBox="1"/>
          <p:nvPr/>
        </p:nvSpPr>
        <p:spPr>
          <a:xfrm>
            <a:off x="7147959" y="3275111"/>
            <a:ext cx="10058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PF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C679702-B224-73AD-D816-ADAB207C52B5}"/>
              </a:ext>
            </a:extLst>
          </p:cNvPr>
          <p:cNvSpPr txBox="1"/>
          <p:nvPr/>
        </p:nvSpPr>
        <p:spPr>
          <a:xfrm>
            <a:off x="1182537" y="6494278"/>
            <a:ext cx="1012707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Helvetica" pitchFamily="2" charset="0"/>
              </a:rPr>
              <a:t>Supplementary Figure S1</a:t>
            </a:r>
            <a:r>
              <a:rPr lang="en-US" sz="1400" dirty="0">
                <a:latin typeface="Helvetica" pitchFamily="2" charset="0"/>
              </a:rPr>
              <a:t>. </a:t>
            </a:r>
            <a:r>
              <a:rPr lang="en-US" sz="1400" b="1" dirty="0">
                <a:latin typeface="Helvetica" pitchFamily="2" charset="0"/>
              </a:rPr>
              <a:t>Sex as a variable of survival. </a:t>
            </a:r>
            <a:r>
              <a:rPr lang="en-US" sz="1400" dirty="0">
                <a:latin typeface="Helvetica" pitchFamily="2" charset="0"/>
              </a:rPr>
              <a:t>Left, females; right, males. Top, overall survival. Bottom, PFS. </a:t>
            </a:r>
          </a:p>
        </p:txBody>
      </p:sp>
    </p:spTree>
    <p:extLst>
      <p:ext uri="{BB962C8B-B14F-4D97-AF65-F5344CB8AC3E}">
        <p14:creationId xmlns:p14="http://schemas.microsoft.com/office/powerpoint/2010/main" val="12864071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33</Words>
  <Application>Microsoft Macintosh PowerPoint</Application>
  <PresentationFormat>Widescreen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ilia Hormigo</dc:creator>
  <cp:lastModifiedBy>Adilia Hormigo</cp:lastModifiedBy>
  <cp:revision>6</cp:revision>
  <dcterms:created xsi:type="dcterms:W3CDTF">2022-05-27T03:46:25Z</dcterms:created>
  <dcterms:modified xsi:type="dcterms:W3CDTF">2023-01-01T00:34:17Z</dcterms:modified>
</cp:coreProperties>
</file>